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1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5BEDF13-48C1-49D8-B30F-7DE01F6E3F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0819BC7-CF56-4315-9323-E570C73CA7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688EF7-9481-46A2-82C2-9CC6C05C0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AC20EC-1A50-4A53-9552-A325893B7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96CE22-37C0-4AEF-93E7-BA0C181B6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006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F4A6D3-CDAF-4B2D-ADF0-3A2ABBB6E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7FC7C67-E50C-4B36-9D1F-F7CBCA551C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BF6DAB-24A4-4AE1-836F-B172D3E88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DEE0B4-7C88-49C4-9062-FA8D878E0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C67CCC-6DB7-4690-9D8C-F5B61EF0F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366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F023525-C72E-4DB5-A4D1-53E252EEFA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DA7728-1002-4E8F-ABF3-6179C1F9DD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A732ED-3633-47AC-8D8F-4303C406E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383A68-E3A3-447A-807B-C099335F9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4A5A55-842B-458E-87BB-D548F29BB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543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B6BDD6-8B6C-49CE-A737-A48CE305A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92CE1DD-5295-408F-B662-91546E1D66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59B0A1D-1596-4329-B91E-4AA4BA1C1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09AC61-B6A9-4325-B6EA-61CBB9BB0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6CB41A-B92F-4436-995A-9590F2510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360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D760BB-AD47-48C5-93F3-B1FDD7125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7474DC-9584-431D-B971-19D01A4781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BC43A-AD15-46CA-9AFB-7750000D6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FD5167-7CF7-4F4C-8422-D4950B573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385D3C-A40F-406A-A05A-486C1193A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363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111CDD-5D1E-435F-B1A1-53913C3334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F55827-9858-4BFD-A72C-88548A185C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D02BE21-397A-4BE9-A49D-0999D5DF40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A59236-7973-4FF1-BE67-9A3524C3D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F9AD16-4BBD-4751-931A-D8929849A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D724CE-94C2-4F1B-A487-89D1CA99C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620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A3329E-E6DA-43C7-9B4B-B8657D449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7203F75-BE8D-4DE5-AB8A-68E6F8384A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2218768-C1FF-44B4-874A-8007749D2E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13AAEA2-5909-43BB-A3EF-B5A877B3E8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B97BBFF-808B-49E3-9C44-1C63BB29DB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334A607-D0B9-42F3-BB8F-E5F230741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AF88814-3EB9-4AF2-9CD4-FC3C8CAA4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5227059-910C-4790-952A-E8E6CEFD0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265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634B34-5A35-456D-8027-224A5B7BE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990B80C-4A86-45AE-8BB9-4440436922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D0E4966-9A4F-4564-9259-77929F50A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A471B4A-48A9-42F5-8770-14FFFC9F7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72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1F0DCA0-9543-4F6C-AA60-CADFD7EE3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D3AAB4D-E3A2-471F-8DE8-96057EA0A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B6E110-2E25-42F9-86ED-B5A5AC6AD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751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C31875-55C2-4A5E-8FB0-98611FFB7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287D29C-C436-464D-8EBD-F3B78C896D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8CF6E62-DB82-40BF-853F-472CE3ADE3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4BB5BD6-78A2-4D3B-9BCB-7B1A626F2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84085CF-C389-4C79-A8FB-DEC128433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B13CF6D-5BA4-40B7-96B3-BD9CB8EE2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4802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D5EC42-69F9-4004-A4D5-6D7B77CB3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D8F301C-0D8E-4801-BA89-53AA1AA669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3B14889-9B2D-4A5A-84F2-7F6F96AA9A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90F6624-A12C-4ECB-866F-A64E7AAD4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EFAE16A-AF16-4E44-B6DA-0891065FC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795E2F-CA75-45B5-A9BA-9B0C82AE8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609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A787FC1-93C0-4348-9921-CA698386ED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95E3928-EA80-4C82-A47B-4C9A42945E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453C4F1-04F6-4139-8C51-C4A1A262EE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04FEC-D061-4AA7-B4FA-8388B904064A}" type="datetimeFigureOut">
              <a:rPr kumimoji="1" lang="ja-JP" altLang="en-US" smtClean="0"/>
              <a:t>2022/1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C2E56A-AFCF-43D7-8C49-1BF3494410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76C20D-D582-4CA6-B5F5-68723A2CAA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FAAE17-89F3-43B3-A99B-21E7A7B905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670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9EE44D4-2968-44C0-AB64-A4ED3C2BFF18}"/>
              </a:ext>
            </a:extLst>
          </p:cNvPr>
          <p:cNvSpPr txBox="1"/>
          <p:nvPr/>
        </p:nvSpPr>
        <p:spPr>
          <a:xfrm>
            <a:off x="627109" y="5121216"/>
            <a:ext cx="86517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SEM image of the FPB-2 treated surface. S4(a) shows the SEM image of the FPB surface at a higher magnification than the Fig. 7. S4(b) shows the composite image of the trapped bacteria and the SEM image of Fig. S4(a). 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5034CEB9-157F-40C4-B2CE-6F418ECF89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78" y="661229"/>
            <a:ext cx="9754445" cy="431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9142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56</Words>
  <Application>Microsoft Office PowerPoint</Application>
  <PresentationFormat>A4 210 x 297 mm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dama nishitani tomoko</dc:creator>
  <cp:lastModifiedBy>kodama nishitani tomoko</cp:lastModifiedBy>
  <cp:revision>5</cp:revision>
  <dcterms:created xsi:type="dcterms:W3CDTF">2022-01-07T00:38:10Z</dcterms:created>
  <dcterms:modified xsi:type="dcterms:W3CDTF">2022-01-14T02:28:13Z</dcterms:modified>
</cp:coreProperties>
</file>